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0991548-4828-4B0C-8472-EAC2B0178C3A}" v="4" dt="2025-07-09T19:35:46.278"/>
    <p1510:client id="{CC50707A-131C-45FF-936F-ECAB474142E7}" v="3" dt="2025-07-09T19:40:12.028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EB9631B5-78F2-41C9-869B-9F39066F8104}" styleName="Medium Style 3 – Accent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9" d="100"/>
          <a:sy n="89" d="100"/>
        </p:scale>
        <p:origin x="787" y="3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avids, Daniel" userId="bd69870e-14b0-4b2a-a293-a297d41864dd" providerId="ADAL" clId="{F360EA8D-2CEF-44DC-A095-62624361F870}"/>
    <pc:docChg chg="custSel addSld modSld">
      <pc:chgData name="Davids, Daniel" userId="bd69870e-14b0-4b2a-a293-a297d41864dd" providerId="ADAL" clId="{F360EA8D-2CEF-44DC-A095-62624361F870}" dt="2024-11-03T19:02:12.238" v="30" actId="1035"/>
      <pc:docMkLst>
        <pc:docMk/>
      </pc:docMkLst>
      <pc:sldChg chg="addSp delSp modSp mod">
        <pc:chgData name="Davids, Daniel" userId="bd69870e-14b0-4b2a-a293-a297d41864dd" providerId="ADAL" clId="{F360EA8D-2CEF-44DC-A095-62624361F870}" dt="2024-11-03T19:02:12.238" v="30" actId="1035"/>
        <pc:sldMkLst>
          <pc:docMk/>
          <pc:sldMk cId="174092475" sldId="257"/>
        </pc:sldMkLst>
      </pc:sldChg>
      <pc:sldChg chg="delSp modSp add mod">
        <pc:chgData name="Davids, Daniel" userId="bd69870e-14b0-4b2a-a293-a297d41864dd" providerId="ADAL" clId="{F360EA8D-2CEF-44DC-A095-62624361F870}" dt="2024-11-03T18:56:55.974" v="23" actId="20577"/>
        <pc:sldMkLst>
          <pc:docMk/>
          <pc:sldMk cId="3475097194" sldId="258"/>
        </pc:sldMkLst>
      </pc:sldChg>
    </pc:docChg>
  </pc:docChgLst>
  <pc:docChgLst>
    <pc:chgData name="Davids, Daniel" userId="bd69870e-14b0-4b2a-a293-a297d41864dd" providerId="ADAL" clId="{CC50707A-131C-45FF-936F-ECAB474142E7}"/>
    <pc:docChg chg="custSel modSld">
      <pc:chgData name="Davids, Daniel" userId="bd69870e-14b0-4b2a-a293-a297d41864dd" providerId="ADAL" clId="{CC50707A-131C-45FF-936F-ECAB474142E7}" dt="2025-07-09T19:40:17.905" v="3" actId="1076"/>
      <pc:docMkLst>
        <pc:docMk/>
      </pc:docMkLst>
      <pc:sldChg chg="addSp delSp modSp mod">
        <pc:chgData name="Davids, Daniel" userId="bd69870e-14b0-4b2a-a293-a297d41864dd" providerId="ADAL" clId="{CC50707A-131C-45FF-936F-ECAB474142E7}" dt="2025-07-09T19:40:17.905" v="3" actId="1076"/>
        <pc:sldMkLst>
          <pc:docMk/>
          <pc:sldMk cId="174092475" sldId="257"/>
        </pc:sldMkLst>
        <pc:graphicFrameChg chg="add mod">
          <ac:chgData name="Davids, Daniel" userId="bd69870e-14b0-4b2a-a293-a297d41864dd" providerId="ADAL" clId="{CC50707A-131C-45FF-936F-ECAB474142E7}" dt="2025-07-09T19:40:07.889" v="1"/>
          <ac:graphicFrameMkLst>
            <pc:docMk/>
            <pc:sldMk cId="174092475" sldId="257"/>
            <ac:graphicFrameMk id="2" creationId="{E9337A5A-E0F7-A8B0-C333-9BC6C0F230A1}"/>
          </ac:graphicFrameMkLst>
        </pc:graphicFrameChg>
        <pc:graphicFrameChg chg="add mod">
          <ac:chgData name="Davids, Daniel" userId="bd69870e-14b0-4b2a-a293-a297d41864dd" providerId="ADAL" clId="{CC50707A-131C-45FF-936F-ECAB474142E7}" dt="2025-07-09T19:40:17.905" v="3" actId="1076"/>
          <ac:graphicFrameMkLst>
            <pc:docMk/>
            <pc:sldMk cId="174092475" sldId="257"/>
            <ac:graphicFrameMk id="3" creationId="{6E0C99F2-F86B-274A-4201-DA74B2E89900}"/>
          </ac:graphicFrameMkLst>
        </pc:graphicFrameChg>
        <pc:graphicFrameChg chg="del">
          <ac:chgData name="Davids, Daniel" userId="bd69870e-14b0-4b2a-a293-a297d41864dd" providerId="ADAL" clId="{CC50707A-131C-45FF-936F-ECAB474142E7}" dt="2025-07-09T19:39:55.338" v="0" actId="478"/>
          <ac:graphicFrameMkLst>
            <pc:docMk/>
            <pc:sldMk cId="174092475" sldId="257"/>
            <ac:graphicFrameMk id="4" creationId="{E0B12A61-35CD-6C46-A602-47E37FE98DF0}"/>
          </ac:graphicFrameMkLst>
        </pc:graphicFrameChg>
      </pc:sldChg>
    </pc:docChg>
  </pc:docChgLst>
  <pc:docChgLst>
    <pc:chgData name="Davids, Daniel" userId="bd69870e-14b0-4b2a-a293-a297d41864dd" providerId="ADAL" clId="{6A553EA6-244C-48F8-95FD-828D1717A47C}"/>
    <pc:docChg chg="custSel addSld delSld modSld">
      <pc:chgData name="Davids, Daniel" userId="bd69870e-14b0-4b2a-a293-a297d41864dd" providerId="ADAL" clId="{6A553EA6-244C-48F8-95FD-828D1717A47C}" dt="2025-03-05T23:50:11.992" v="16" actId="1076"/>
      <pc:docMkLst>
        <pc:docMk/>
      </pc:docMkLst>
      <pc:sldChg chg="addSp delSp modSp mod">
        <pc:chgData name="Davids, Daniel" userId="bd69870e-14b0-4b2a-a293-a297d41864dd" providerId="ADAL" clId="{6A553EA6-244C-48F8-95FD-828D1717A47C}" dt="2025-03-05T23:50:11.992" v="16" actId="1076"/>
        <pc:sldMkLst>
          <pc:docMk/>
          <pc:sldMk cId="174092475" sldId="257"/>
        </pc:sldMkLst>
      </pc:sldChg>
      <pc:sldChg chg="del">
        <pc:chgData name="Davids, Daniel" userId="bd69870e-14b0-4b2a-a293-a297d41864dd" providerId="ADAL" clId="{6A553EA6-244C-48F8-95FD-828D1717A47C}" dt="2025-03-05T21:20:23.750" v="3" actId="47"/>
        <pc:sldMkLst>
          <pc:docMk/>
          <pc:sldMk cId="3475097194" sldId="258"/>
        </pc:sldMkLst>
      </pc:sldChg>
      <pc:sldChg chg="add del">
        <pc:chgData name="Davids, Daniel" userId="bd69870e-14b0-4b2a-a293-a297d41864dd" providerId="ADAL" clId="{6A553EA6-244C-48F8-95FD-828D1717A47C}" dt="2025-03-05T21:20:16.677" v="2" actId="47"/>
        <pc:sldMkLst>
          <pc:docMk/>
          <pc:sldMk cId="4035310119" sldId="259"/>
        </pc:sldMkLst>
      </pc:sldChg>
      <pc:sldChg chg="add del">
        <pc:chgData name="Davids, Daniel" userId="bd69870e-14b0-4b2a-a293-a297d41864dd" providerId="ADAL" clId="{6A553EA6-244C-48F8-95FD-828D1717A47C}" dt="2025-03-05T21:20:16.677" v="2" actId="47"/>
        <pc:sldMkLst>
          <pc:docMk/>
          <pc:sldMk cId="3572187018" sldId="260"/>
        </pc:sldMkLst>
      </pc:sldChg>
    </pc:docChg>
  </pc:docChgLst>
  <pc:docChgLst>
    <pc:chgData name="Davids, Daniel" userId="bd69870e-14b0-4b2a-a293-a297d41864dd" providerId="ADAL" clId="{B0D606D2-1008-41BC-A72F-F713ABC021F4}"/>
    <pc:docChg chg="addSld delSld modSld">
      <pc:chgData name="Davids, Daniel" userId="bd69870e-14b0-4b2a-a293-a297d41864dd" providerId="ADAL" clId="{B0D606D2-1008-41BC-A72F-F713ABC021F4}" dt="2024-11-03T18:32:44.267" v="35" actId="47"/>
      <pc:docMkLst>
        <pc:docMk/>
      </pc:docMkLst>
      <pc:sldChg chg="new del">
        <pc:chgData name="Davids, Daniel" userId="bd69870e-14b0-4b2a-a293-a297d41864dd" providerId="ADAL" clId="{B0D606D2-1008-41BC-A72F-F713ABC021F4}" dt="2024-11-03T18:19:33.782" v="2" actId="47"/>
        <pc:sldMkLst>
          <pc:docMk/>
          <pc:sldMk cId="2106742275" sldId="256"/>
        </pc:sldMkLst>
      </pc:sldChg>
      <pc:sldChg chg="addSp delSp modSp new mod">
        <pc:chgData name="Davids, Daniel" userId="bd69870e-14b0-4b2a-a293-a297d41864dd" providerId="ADAL" clId="{B0D606D2-1008-41BC-A72F-F713ABC021F4}" dt="2024-11-03T18:31:45.297" v="32" actId="14100"/>
        <pc:sldMkLst>
          <pc:docMk/>
          <pc:sldMk cId="174092475" sldId="257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3261132528" sldId="258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3129412391" sldId="259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459212972" sldId="260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3083949308" sldId="261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3847408672" sldId="262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110391834" sldId="263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3546292502" sldId="264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3035228439" sldId="265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1002150119" sldId="266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2056411075" sldId="267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3923372120" sldId="268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752528510" sldId="269"/>
        </pc:sldMkLst>
      </pc:sldChg>
      <pc:sldChg chg="add del">
        <pc:chgData name="Davids, Daniel" userId="bd69870e-14b0-4b2a-a293-a297d41864dd" providerId="ADAL" clId="{B0D606D2-1008-41BC-A72F-F713ABC021F4}" dt="2024-11-03T18:32:35.079" v="34" actId="47"/>
        <pc:sldMkLst>
          <pc:docMk/>
          <pc:sldMk cId="2664668440" sldId="270"/>
        </pc:sldMkLst>
      </pc:sldChg>
      <pc:sldChg chg="add del">
        <pc:chgData name="Davids, Daniel" userId="bd69870e-14b0-4b2a-a293-a297d41864dd" providerId="ADAL" clId="{B0D606D2-1008-41BC-A72F-F713ABC021F4}" dt="2024-11-03T18:32:35.079" v="34" actId="47"/>
        <pc:sldMkLst>
          <pc:docMk/>
          <pc:sldMk cId="107856901" sldId="271"/>
        </pc:sldMkLst>
      </pc:sldChg>
      <pc:sldChg chg="add del">
        <pc:chgData name="Davids, Daniel" userId="bd69870e-14b0-4b2a-a293-a297d41864dd" providerId="ADAL" clId="{B0D606D2-1008-41BC-A72F-F713ABC021F4}" dt="2024-11-03T18:32:32.890" v="33" actId="47"/>
        <pc:sldMkLst>
          <pc:docMk/>
          <pc:sldMk cId="1885141936" sldId="272"/>
        </pc:sldMkLst>
      </pc:sldChg>
    </pc:docChg>
  </pc:docChgLst>
  <pc:docChgLst>
    <pc:chgData name="Davids, Daniel" userId="bd69870e-14b0-4b2a-a293-a297d41864dd" providerId="ADAL" clId="{80991548-4828-4B0C-8472-EAC2B0178C3A}"/>
    <pc:docChg chg="custSel modSld">
      <pc:chgData name="Davids, Daniel" userId="bd69870e-14b0-4b2a-a293-a297d41864dd" providerId="ADAL" clId="{80991548-4828-4B0C-8472-EAC2B0178C3A}" dt="2025-07-09T19:35:53.748" v="3" actId="1076"/>
      <pc:docMkLst>
        <pc:docMk/>
      </pc:docMkLst>
      <pc:sldChg chg="addSp delSp modSp mod">
        <pc:chgData name="Davids, Daniel" userId="bd69870e-14b0-4b2a-a293-a297d41864dd" providerId="ADAL" clId="{80991548-4828-4B0C-8472-EAC2B0178C3A}" dt="2025-07-09T19:35:53.748" v="3" actId="1076"/>
        <pc:sldMkLst>
          <pc:docMk/>
          <pc:sldMk cId="174092475" sldId="257"/>
        </pc:sldMkLst>
        <pc:graphicFrameChg chg="add mod">
          <ac:chgData name="Davids, Daniel" userId="bd69870e-14b0-4b2a-a293-a297d41864dd" providerId="ADAL" clId="{80991548-4828-4B0C-8472-EAC2B0178C3A}" dt="2025-07-09T19:35:38.190" v="1"/>
          <ac:graphicFrameMkLst>
            <pc:docMk/>
            <pc:sldMk cId="174092475" sldId="257"/>
            <ac:graphicFrameMk id="2" creationId="{E32B4A51-178D-C890-AB83-2FB66FFC672E}"/>
          </ac:graphicFrameMkLst>
        </pc:graphicFrameChg>
        <pc:graphicFrameChg chg="del">
          <ac:chgData name="Davids, Daniel" userId="bd69870e-14b0-4b2a-a293-a297d41864dd" providerId="ADAL" clId="{80991548-4828-4B0C-8472-EAC2B0178C3A}" dt="2025-07-09T19:33:30.622" v="0" actId="478"/>
          <ac:graphicFrameMkLst>
            <pc:docMk/>
            <pc:sldMk cId="174092475" sldId="257"/>
            <ac:graphicFrameMk id="3" creationId="{628EA2F4-7C09-610F-3DE6-012586300E54}"/>
          </ac:graphicFrameMkLst>
        </pc:graphicFrameChg>
        <pc:graphicFrameChg chg="add mod">
          <ac:chgData name="Davids, Daniel" userId="bd69870e-14b0-4b2a-a293-a297d41864dd" providerId="ADAL" clId="{80991548-4828-4B0C-8472-EAC2B0178C3A}" dt="2025-07-09T19:35:53.748" v="3" actId="1076"/>
          <ac:graphicFrameMkLst>
            <pc:docMk/>
            <pc:sldMk cId="174092475" sldId="257"/>
            <ac:graphicFrameMk id="4" creationId="{E0B12A61-35CD-6C46-A602-47E37FE98DF0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04686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876092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91971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80267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265694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02484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7901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50910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62804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756778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22955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19663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6E0C99F2-F86B-274A-4201-DA74B2E8990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88271736"/>
              </p:ext>
            </p:extLst>
          </p:nvPr>
        </p:nvGraphicFramePr>
        <p:xfrm>
          <a:off x="1631950" y="2160111"/>
          <a:ext cx="8928100" cy="1463040"/>
        </p:xfrm>
        <a:graphic>
          <a:graphicData uri="http://schemas.openxmlformats.org/drawingml/2006/table">
            <a:tbl>
              <a:tblPr firstRow="1" firstCol="1" bandRow="1"/>
              <a:tblGrid>
                <a:gridCol w="1710690">
                  <a:extLst>
                    <a:ext uri="{9D8B030D-6E8A-4147-A177-3AD203B41FA5}">
                      <a16:colId xmlns:a16="http://schemas.microsoft.com/office/drawing/2014/main" val="3510546546"/>
                    </a:ext>
                  </a:extLst>
                </a:gridCol>
                <a:gridCol w="1604010">
                  <a:extLst>
                    <a:ext uri="{9D8B030D-6E8A-4147-A177-3AD203B41FA5}">
                      <a16:colId xmlns:a16="http://schemas.microsoft.com/office/drawing/2014/main" val="3558840641"/>
                    </a:ext>
                  </a:extLst>
                </a:gridCol>
                <a:gridCol w="1384300">
                  <a:extLst>
                    <a:ext uri="{9D8B030D-6E8A-4147-A177-3AD203B41FA5}">
                      <a16:colId xmlns:a16="http://schemas.microsoft.com/office/drawing/2014/main" val="911003015"/>
                    </a:ext>
                  </a:extLst>
                </a:gridCol>
                <a:gridCol w="1384300">
                  <a:extLst>
                    <a:ext uri="{9D8B030D-6E8A-4147-A177-3AD203B41FA5}">
                      <a16:colId xmlns:a16="http://schemas.microsoft.com/office/drawing/2014/main" val="2026780248"/>
                    </a:ext>
                  </a:extLst>
                </a:gridCol>
                <a:gridCol w="1460500">
                  <a:extLst>
                    <a:ext uri="{9D8B030D-6E8A-4147-A177-3AD203B41FA5}">
                      <a16:colId xmlns:a16="http://schemas.microsoft.com/office/drawing/2014/main" val="2181696238"/>
                    </a:ext>
                  </a:extLst>
                </a:gridCol>
                <a:gridCol w="1384300">
                  <a:extLst>
                    <a:ext uri="{9D8B030D-6E8A-4147-A177-3AD203B41FA5}">
                      <a16:colId xmlns:a16="http://schemas.microsoft.com/office/drawing/2014/main" val="1622881514"/>
                    </a:ext>
                  </a:extLst>
                </a:gridCol>
              </a:tblGrid>
              <a:tr h="182880">
                <a:tc gridSpan="6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y = Intercept + B1*x^1 + B2*x^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4814809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lot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125% Methane Leakag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5% Methane Leakag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% Methane Leakag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5% Methane Leakag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.5% Methane Leakag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24353913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Intercept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59727 ± 0.0304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.01545 ± 0.3542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.27455 ± 0.29747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.36513 ± 1.7945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.00818 ± 0.1030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1268742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B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0066 ± 0.5686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-3.45206 ± 3.4276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-8.92063 ± 1.77719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-16.21466 ± 7.7817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-10.3548 ± 0.289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92141616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B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-8.11593 ± 2.3212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.1398 ± 7.9418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9.29724 ± 2.6090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5.52062 ± 8.3587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.8987 ± 0.2021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1522629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Residual Sum of Squares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.68E-0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.48E-0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.91E-0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.07E-0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.55E-07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12422230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R-Square (COD)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9986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9859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999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97977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9998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8529230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Adj. R-Squar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9958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9577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997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939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99957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2282692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740924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4</TotalTime>
  <Words>115</Words>
  <Application>Microsoft Office PowerPoint</Application>
  <PresentationFormat>Widescreen</PresentationFormat>
  <Paragraphs>4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Davids, Daniel</dc:creator>
  <cp:lastModifiedBy>Davids, Daniel</cp:lastModifiedBy>
  <cp:revision>1</cp:revision>
  <dcterms:created xsi:type="dcterms:W3CDTF">2024-11-03T18:19:26Z</dcterms:created>
  <dcterms:modified xsi:type="dcterms:W3CDTF">2025-07-09T19:40:18Z</dcterms:modified>
</cp:coreProperties>
</file>